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-3156" y="-9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80050681-A6E7-CB34-776C-A39448932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:a16="http://schemas.microsoft.com/office/drawing/2014/main" xmlns="" id="{B72927D1-72F9-3937-65BB-BC2D5CF3D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B7FFD7E8-8911-5351-E2CE-F6E43811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C65C6ADA-DF1A-22A7-389D-48B49E826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9286EA4A-99FC-AE9D-E08A-9E6BCE41D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7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FE70942C-1F5F-C0B1-C660-EED1689FA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xmlns="" id="{F7A6F098-3AE5-49DF-F65D-2343EEB7F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019F7976-9D0C-EDD2-4C13-A76724BDD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43F07E5B-6C33-5E41-A73F-960A5058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C5416937-6BAF-D56B-AC22-EFFC83807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04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:a16="http://schemas.microsoft.com/office/drawing/2014/main" xmlns="" id="{8AEBD049-29D2-C7E4-0FA7-4CB5B0E925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xmlns="" id="{81775499-822A-1621-FF9C-954167751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842DCA56-F96C-1D02-23A3-952C52C6B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7C23E8F8-3995-5AA5-E538-1D7767F57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681A1687-6E0E-B5A1-1E47-BDB5D55E3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96791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4D8AFF0F-5700-B26D-6510-E4B581252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C2616D5E-F700-2C5B-2525-D9ABBA32FA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7B6F5DD9-7D53-1F8E-F8AB-03C3596A0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BEF23A49-E9C4-4C96-6225-E9A89D96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7A5B151E-E8EA-32ED-F282-DB4295BCC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75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4FAC267D-330B-F6AF-4194-8CB242E8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CEC20DB7-BF07-D2EB-CBEE-8BEF5DA20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D2D12727-0D8C-0D98-E2D9-8D5A8DB9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D72BD71C-EDB5-6022-A4E0-4B399797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C720F283-4064-E1C7-CA01-158A50CB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07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28696025-4BA6-501D-A54D-573AA70F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6593ACB2-7908-2D5F-7A5A-67103E6F2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xmlns="" id="{39B666E6-8B5D-4A84-E584-76E0313E9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E18E3FE3-CE0E-6BBE-1373-B4FF91DB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D6B99DBB-D291-B70F-51C5-6DCDC658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F0A93378-1089-DAD4-CBF2-5E2FC5DF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32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A6820180-2B1F-7E86-1C85-028489FD2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EEA8BD1E-7645-FAF4-9F72-EF8F78D4F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xmlns="" id="{E92BEE2D-3AFB-C625-6DE2-8C76C27EB4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:a16="http://schemas.microsoft.com/office/drawing/2014/main" xmlns="" id="{D48BAEFA-4424-02C9-EB89-03A28F2BCD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:a16="http://schemas.microsoft.com/office/drawing/2014/main" xmlns="" id="{15C41A3B-AA13-F21F-B349-2478C82EDE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:a16="http://schemas.microsoft.com/office/drawing/2014/main" xmlns="" id="{F0582415-56DC-B170-CDF0-BE62EFA9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:a16="http://schemas.microsoft.com/office/drawing/2014/main" xmlns="" id="{9D6EFAC7-B063-911F-7F4E-3F19049E3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:a16="http://schemas.microsoft.com/office/drawing/2014/main" xmlns="" id="{8615E53A-1EF6-4E23-2F17-469E4F077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892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FE3B1CE2-671B-89DF-FD96-BF399AC6C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:a16="http://schemas.microsoft.com/office/drawing/2014/main" xmlns="" id="{CD966B3B-14C6-4C2A-8BCF-5AC15AF6A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:a16="http://schemas.microsoft.com/office/drawing/2014/main" xmlns="" id="{61EE871A-067C-4449-D4D3-F240132B7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:a16="http://schemas.microsoft.com/office/drawing/2014/main" xmlns="" id="{2A2DFCB0-E29A-AD2B-14A6-DCD6F79FD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1252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:a16="http://schemas.microsoft.com/office/drawing/2014/main" xmlns="" id="{B326F172-39F4-44FD-B858-0F4FED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:a16="http://schemas.microsoft.com/office/drawing/2014/main" xmlns="" id="{843C5D89-BAEB-7FB1-8323-6A4F11E5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:a16="http://schemas.microsoft.com/office/drawing/2014/main" xmlns="" id="{1D54F48A-EF69-D74B-2200-1351DE33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175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FE32B685-E62F-17A9-476C-E14014806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BD605308-4383-0779-8E55-0E3B027A4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xmlns="" id="{7A7238C4-3A51-1C78-931B-E7B7374248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CE62676F-B03B-3404-BCF7-7B822770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889DEF69-5A9D-EEB3-C2A4-12A9C7E14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FEB9A95A-8412-41DC-FA9A-3C907742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65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C0C8E5B2-EBF3-EF94-A6C4-A37CD31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:a16="http://schemas.microsoft.com/office/drawing/2014/main" xmlns="" id="{67A90359-6F91-3B96-CED3-CF304C4EC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xmlns="" id="{A387EA31-F8C7-732C-072D-349717764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8147160C-4191-6406-5182-FCE5EE9E0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FAAAC055-D406-0213-2907-8A8DFC684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94D46E60-6FCF-8EBF-1455-9BA07E3D9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380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2F918E65-B4F6-4D4B-15CA-EB4E976DC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D3EE80B9-9D15-32B0-2C6B-B0B4CBC75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7F19557F-66E9-9344-74A8-C96C42B184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A93133E5-9E8B-012A-757F-3101932A8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8FEEC80B-B08C-A809-F323-54607FFD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693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54D09361-B79C-DFC0-0777-9FBA893FA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438" y="99951"/>
            <a:ext cx="7886700" cy="476123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al-time reverse transcription polymerase chain reaction (RT-PCR) verification of the RNA-Seq results.</a:t>
            </a:r>
            <a:endParaRPr lang="ru-R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B5A1926C-F1CF-5BDA-0061-F4962B0CE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5448" y="5943600"/>
            <a:ext cx="8862822" cy="57607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ata for comparison in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R24-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O24-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re shown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even gene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, whose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value lower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05, wer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elected for PCR-analysis. Reference gene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was used to normalize PCR-results.</a:t>
            </a:r>
            <a:endParaRPr lang="ru-RU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 descr="K:\Редактируемые\Для публикаций\0_текущие публикации\ишемия_2\кора\статья по 24 часам DRFC\fs2-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10740" y="1029258"/>
            <a:ext cx="4670743" cy="45946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0377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51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Figure S2. Real-time reverse transcription polymerase chain reaction (RT-PCR) verification of the RNA-Seq results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Real-time reverse transcription polymerase chain reaction (RT-PCR) verification of the RNA-Seq results.</dc:title>
  <dc:creator>Maria Manor</dc:creator>
  <cp:lastModifiedBy>Ivan</cp:lastModifiedBy>
  <cp:revision>7</cp:revision>
  <dcterms:created xsi:type="dcterms:W3CDTF">2023-01-16T11:00:34Z</dcterms:created>
  <dcterms:modified xsi:type="dcterms:W3CDTF">2024-11-11T09:00:15Z</dcterms:modified>
</cp:coreProperties>
</file>